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handoutMasterIdLst>
    <p:handoutMasterId r:id="rId7"/>
  </p:handoutMasterIdLst>
  <p:sldIdLst>
    <p:sldId id="326" r:id="rId2"/>
    <p:sldId id="333" r:id="rId3"/>
    <p:sldId id="334" r:id="rId4"/>
    <p:sldId id="322" r:id="rId5"/>
  </p:sldIdLst>
  <p:sldSz cx="9144000" cy="6858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655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2080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1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929760-B391-43EE-8510-74C84E9C8D9F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3AA3CD-54A7-42C3-8AEF-663A1ECBA5C8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01604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7759C41-49E3-42E9-90A5-B38E54FF2CA0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B2B07C6-68D4-4CD7-A104-13F06E8D22C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53730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73748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50838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6543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2653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50594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5553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80831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5745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21753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7686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7969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C49B54-0932-4E1E-BD7F-CEC36E832DFA}" type="datetimeFigureOut">
              <a:rPr lang="ko-KR" altLang="en-US" smtClean="0"/>
              <a:pPr/>
              <a:t>2019. 12. 6.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BBB321-22A0-4650-A183-F8BC038BB13C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24677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그룹 9"/>
          <p:cNvGrpSpPr/>
          <p:nvPr/>
        </p:nvGrpSpPr>
        <p:grpSpPr>
          <a:xfrm>
            <a:off x="1045324" y="1230932"/>
            <a:ext cx="6841376" cy="4380894"/>
            <a:chOff x="130924" y="1238552"/>
            <a:chExt cx="6841376" cy="4380894"/>
          </a:xfrm>
        </p:grpSpPr>
        <p:sp>
          <p:nvSpPr>
            <p:cNvPr id="7" name="TextBox 6"/>
            <p:cNvSpPr txBox="1"/>
            <p:nvPr/>
          </p:nvSpPr>
          <p:spPr>
            <a:xfrm>
              <a:off x="130924" y="1238552"/>
              <a:ext cx="3429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그림 7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182"/>
            <a:stretch/>
          </p:blipFill>
          <p:spPr>
            <a:xfrm>
              <a:off x="130924" y="1546329"/>
              <a:ext cx="6841376" cy="4073117"/>
            </a:xfrm>
            <a:prstGeom prst="rect">
              <a:avLst/>
            </a:prstGeom>
          </p:spPr>
        </p:pic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93698425-8391-CF43-BB87-C86A851E4CF6}"/>
              </a:ext>
            </a:extLst>
          </p:cNvPr>
          <p:cNvSpPr txBox="1"/>
          <p:nvPr/>
        </p:nvSpPr>
        <p:spPr>
          <a:xfrm>
            <a:off x="0" y="0"/>
            <a:ext cx="884582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400" b="1" dirty="0"/>
              <a:t>Flow cytometry analyses of the genome editing specificities of the sgRNAs targeting the RFP-GFP dual reporters. </a:t>
            </a:r>
            <a:r>
              <a:rPr lang="en-US" sz="1400" dirty="0"/>
              <a:t>(A) and (B) indicate the fluorescence profiles of biological replicates.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29136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0"/>
            <a:ext cx="88458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1098664" y="1230932"/>
            <a:ext cx="6783426" cy="4255468"/>
            <a:chOff x="130924" y="1238552"/>
            <a:chExt cx="6783426" cy="4255468"/>
          </a:xfrm>
        </p:grpSpPr>
        <p:sp>
          <p:nvSpPr>
            <p:cNvPr id="7" name="TextBox 6"/>
            <p:cNvSpPr txBox="1"/>
            <p:nvPr/>
          </p:nvSpPr>
          <p:spPr>
            <a:xfrm>
              <a:off x="130924" y="1238552"/>
              <a:ext cx="3429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" name="그림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5286" b="45437"/>
            <a:stretch/>
          </p:blipFill>
          <p:spPr>
            <a:xfrm>
              <a:off x="130924" y="1546328"/>
              <a:ext cx="6783426" cy="394769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407900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Box 36"/>
          <p:cNvSpPr txBox="1"/>
          <p:nvPr/>
        </p:nvSpPr>
        <p:spPr>
          <a:xfrm>
            <a:off x="-1" y="0"/>
            <a:ext cx="8895523" cy="8925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ko-KR" alt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7E1 analyses of the 15 candidate off-target site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) Off-target analyses of off-targets using MT reporter and sgRNA(1). (B) Analyses of off-targets using WT reporter and sgRNA(1)</a:t>
            </a:r>
          </a:p>
          <a:p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A223E0E1-1612-F84C-AA8E-17D024CC6A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8133" y="1113183"/>
            <a:ext cx="6487733" cy="544159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BC2DACE-A6DF-834C-80B3-226DEC56E7EF}"/>
              </a:ext>
            </a:extLst>
          </p:cNvPr>
          <p:cNvSpPr txBox="1"/>
          <p:nvPr/>
        </p:nvSpPr>
        <p:spPr>
          <a:xfrm>
            <a:off x="1156683" y="1113183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524269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257696" y="2315014"/>
            <a:ext cx="12567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cs typeface="Times New Roman" panose="02020603050405020304" pitchFamily="18" charset="0"/>
              </a:rPr>
              <a:t>(</a:t>
            </a:r>
            <a:r>
              <a:rPr lang="en-US" altLang="ko-KR" sz="1200" b="1" dirty="0" err="1">
                <a:cs typeface="Times New Roman" panose="02020603050405020304" pitchFamily="18" charset="0"/>
              </a:rPr>
              <a:t>WT_reporter</a:t>
            </a:r>
            <a:r>
              <a:rPr lang="en-US" altLang="ko-KR" sz="1200" b="1" dirty="0">
                <a:cs typeface="Times New Roman" panose="02020603050405020304" pitchFamily="18" charset="0"/>
              </a:rPr>
              <a:t> only)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/>
          <a:srcRect l="2165" t="77723" r="5493" b="5997"/>
          <a:stretch/>
        </p:blipFill>
        <p:spPr>
          <a:xfrm>
            <a:off x="1743075" y="4057952"/>
            <a:ext cx="5892228" cy="904875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 rotWithShape="1">
          <a:blip r:embed="rId2"/>
          <a:srcRect t="2397" r="7583" b="79953"/>
          <a:stretch/>
        </p:blipFill>
        <p:spPr>
          <a:xfrm>
            <a:off x="1724292" y="1528050"/>
            <a:ext cx="5897034" cy="981075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57696" y="4883819"/>
            <a:ext cx="12567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>
                <a:cs typeface="Times New Roman" panose="02020603050405020304" pitchFamily="18" charset="0"/>
              </a:rPr>
              <a:t>(</a:t>
            </a:r>
            <a:r>
              <a:rPr lang="en-US" altLang="ko-KR" sz="1200" b="1" dirty="0" err="1">
                <a:cs typeface="Times New Roman" panose="02020603050405020304" pitchFamily="18" charset="0"/>
              </a:rPr>
              <a:t>WT_reporter</a:t>
            </a:r>
            <a:endParaRPr lang="en-US" altLang="ko-KR" sz="1200" b="1" dirty="0">
              <a:cs typeface="Times New Roman" panose="02020603050405020304" pitchFamily="18" charset="0"/>
            </a:endParaRPr>
          </a:p>
          <a:p>
            <a:pPr algn="ctr"/>
            <a:r>
              <a:rPr lang="en-US" altLang="ko-KR" sz="1200" b="1" dirty="0" err="1">
                <a:cs typeface="Times New Roman" panose="02020603050405020304" pitchFamily="18" charset="0"/>
              </a:rPr>
              <a:t>sgRNA</a:t>
            </a:r>
            <a:r>
              <a:rPr lang="en-US" altLang="ko-KR" sz="1200" b="1" dirty="0">
                <a:cs typeface="Times New Roman" panose="02020603050405020304" pitchFamily="18" charset="0"/>
              </a:rPr>
              <a:t>(1))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106703">
            <a:off x="1876951" y="1032641"/>
            <a:ext cx="927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1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8106703">
            <a:off x="2308595" y="1032642"/>
            <a:ext cx="927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2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8106703">
            <a:off x="2661062" y="1032641"/>
            <a:ext cx="927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3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8106703">
            <a:off x="3035556" y="1032642"/>
            <a:ext cx="927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4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8106703">
            <a:off x="3411037" y="1032640"/>
            <a:ext cx="927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5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8106703">
            <a:off x="3804581" y="1032641"/>
            <a:ext cx="927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6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8106703">
            <a:off x="4172000" y="1032641"/>
            <a:ext cx="927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7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8106703">
            <a:off x="4546494" y="1032642"/>
            <a:ext cx="927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8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8106703">
            <a:off x="4956111" y="1032641"/>
            <a:ext cx="927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9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8106703">
            <a:off x="5219139" y="969308"/>
            <a:ext cx="10769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10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8106703">
            <a:off x="5597612" y="957574"/>
            <a:ext cx="11045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11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8106703">
            <a:off x="5970338" y="971505"/>
            <a:ext cx="10717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12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8106703">
            <a:off x="6362880" y="993403"/>
            <a:ext cx="10202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13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8106703">
            <a:off x="6672322" y="945003"/>
            <a:ext cx="1134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14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8106703">
            <a:off x="7053769" y="957574"/>
            <a:ext cx="1134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Off-target15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pic>
        <p:nvPicPr>
          <p:cNvPr id="27" name="그림 26"/>
          <p:cNvPicPr>
            <a:picLocks noChangeAspect="1"/>
          </p:cNvPicPr>
          <p:nvPr/>
        </p:nvPicPr>
        <p:blipFill rotWithShape="1">
          <a:blip r:embed="rId3"/>
          <a:srcRect l="1145" t="5786" r="6995" b="73230"/>
          <a:stretch/>
        </p:blipFill>
        <p:spPr>
          <a:xfrm>
            <a:off x="1743075" y="2667073"/>
            <a:ext cx="5892228" cy="1105213"/>
          </a:xfrm>
          <a:prstGeom prst="rect">
            <a:avLst/>
          </a:prstGeom>
        </p:spPr>
      </p:pic>
      <p:pic>
        <p:nvPicPr>
          <p:cNvPr id="28" name="그림 27"/>
          <p:cNvPicPr>
            <a:picLocks noChangeAspect="1"/>
          </p:cNvPicPr>
          <p:nvPr/>
        </p:nvPicPr>
        <p:blipFill rotWithShape="1">
          <a:blip r:embed="rId3"/>
          <a:srcRect l="1218" t="71755" r="7440" b="5459"/>
          <a:stretch/>
        </p:blipFill>
        <p:spPr>
          <a:xfrm>
            <a:off x="1724025" y="5114652"/>
            <a:ext cx="5897301" cy="1200108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7703363" y="2038015"/>
            <a:ext cx="6121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PCR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703363" y="4370641"/>
            <a:ext cx="6121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PCR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703363" y="3112484"/>
            <a:ext cx="6121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T7E1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703363" y="5573310"/>
            <a:ext cx="6121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cs typeface="Times New Roman" panose="02020603050405020304" pitchFamily="18" charset="0"/>
              </a:rPr>
              <a:t>T7E1</a:t>
            </a:r>
            <a:endParaRPr lang="ko-KR" altLang="en-US" sz="1200" b="1" dirty="0">
              <a:cs typeface="Times New Roman" panose="02020603050405020304" pitchFamily="18" charset="0"/>
            </a:endParaRPr>
          </a:p>
        </p:txBody>
      </p:sp>
      <p:cxnSp>
        <p:nvCxnSpPr>
          <p:cNvPr id="34" name="직선 연결선 33"/>
          <p:cNvCxnSpPr/>
          <p:nvPr/>
        </p:nvCxnSpPr>
        <p:spPr>
          <a:xfrm flipH="1">
            <a:off x="1559676" y="1778374"/>
            <a:ext cx="9525" cy="17773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직선 연결선 34"/>
          <p:cNvCxnSpPr/>
          <p:nvPr/>
        </p:nvCxnSpPr>
        <p:spPr>
          <a:xfrm flipH="1">
            <a:off x="1559676" y="4350257"/>
            <a:ext cx="9525" cy="17773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0" y="8578"/>
            <a:ext cx="322834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ko-KR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02ABD32-809A-FC47-B939-0E33CC9205FF}"/>
              </a:ext>
            </a:extLst>
          </p:cNvPr>
          <p:cNvSpPr txBox="1"/>
          <p:nvPr/>
        </p:nvSpPr>
        <p:spPr>
          <a:xfrm>
            <a:off x="412438" y="799779"/>
            <a:ext cx="3429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3078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 rtlCol="0">
        <a:spAutoFit/>
      </a:bodyPr>
      <a:lstStyle>
        <a:defPPr>
          <a:defRPr sz="1500" dirty="0" err="1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37</TotalTime>
  <Words>118</Words>
  <Application>Microsoft Macintosh PowerPoint</Application>
  <PresentationFormat>On-screen Show (4:3)</PresentationFormat>
  <Paragraphs>30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Office 테마</vt:lpstr>
      <vt:lpstr>PowerPoint Presentation</vt:lpstr>
      <vt:lpstr>PowerPoint Presentation</vt:lpstr>
      <vt:lpstr>PowerPoint Presentation</vt:lpstr>
      <vt:lpstr>PowerPoint Presentation</vt:lpstr>
    </vt:vector>
  </TitlesOfParts>
  <Company>Windows 사용자 조직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Junho Hur</cp:lastModifiedBy>
  <cp:revision>174</cp:revision>
  <cp:lastPrinted>2019-06-17T01:05:41Z</cp:lastPrinted>
  <dcterms:created xsi:type="dcterms:W3CDTF">2018-12-18T00:42:52Z</dcterms:created>
  <dcterms:modified xsi:type="dcterms:W3CDTF">2019-12-06T09:13:47Z</dcterms:modified>
</cp:coreProperties>
</file>